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DB071-0FAF-4E14-8165-C0161B32C9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B3B596-580A-4862-A2E1-48CF15CF91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62B290-834B-4871-89A1-0EC6473A3A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7EF36-EFD6-42C6-BA49-DCC321D1CF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34D7AB-8EB8-4B06-BFE7-8BC3EEA11F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5581C3-EE1A-49BF-9C06-3920ED0C5F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98CE8-20C7-46AF-BC6B-1618696A0C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D3FF0-0260-4A72-9647-BA4287DD0E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80FF7-60B2-420C-8A62-33544F6223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89B1F-45C5-45B6-9F5D-26A988C223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C26F6-B5C1-46A5-890C-32D6163A77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E7E83-7C5B-4375-8F73-66B558934D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E9FDFCA-ADF1-47F5-834A-4DA4D7A35282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23F0237-3967-4A38-A5CA-73850BE044D1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Diagramm 4" descr=""/>
          <p:cNvPicPr/>
          <p:nvPr/>
        </p:nvPicPr>
        <p:blipFill>
          <a:blip r:embed="rId1"/>
          <a:stretch/>
        </p:blipFill>
        <p:spPr>
          <a:xfrm>
            <a:off x="328680" y="1427040"/>
            <a:ext cx="4120920" cy="2638440"/>
          </a:xfrm>
          <a:prstGeom prst="rect">
            <a:avLst/>
          </a:prstGeom>
          <a:ln w="0">
            <a:noFill/>
          </a:ln>
        </p:spPr>
      </p:pic>
      <p:sp>
        <p:nvSpPr>
          <p:cNvPr id="42" name="Textfeld 5"/>
          <p:cNvSpPr/>
          <p:nvPr/>
        </p:nvSpPr>
        <p:spPr>
          <a:xfrm>
            <a:off x="4377960" y="1893960"/>
            <a:ext cx="74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=0.03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feld 119"/>
          <p:cNvSpPr/>
          <p:nvPr/>
        </p:nvSpPr>
        <p:spPr>
          <a:xfrm>
            <a:off x="338040" y="414360"/>
            <a:ext cx="210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upplementary Figure S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feld 8"/>
          <p:cNvSpPr/>
          <p:nvPr/>
        </p:nvSpPr>
        <p:spPr>
          <a:xfrm>
            <a:off x="333360" y="844560"/>
            <a:ext cx="458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equency of T790M mutation in pre-treatment tumor specime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feld 5"/>
          <p:cNvSpPr/>
          <p:nvPr/>
        </p:nvSpPr>
        <p:spPr>
          <a:xfrm>
            <a:off x="1876320" y="3994200"/>
            <a:ext cx="175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ead frequenc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23T20:04:50Z</dcterms:created>
  <dc:creator>Thomas Zander</dc:creator>
  <dc:description/>
  <dc:language>en-US</dc:language>
  <cp:lastModifiedBy>Sascha Ansen</cp:lastModifiedBy>
  <dcterms:modified xsi:type="dcterms:W3CDTF">2011-03-29T12:49:30Z</dcterms:modified>
  <cp:revision>15</cp:revision>
  <dc:subject/>
  <dc:title>Folie 1</dc:title>
</cp:coreProperties>
</file>